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40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4948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4160" y="-360"/>
            <a:ext cx="294948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66760" y="1243080"/>
            <a:ext cx="4471920" cy="3354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82960"/>
            <a:ext cx="5443560" cy="391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948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4160" y="9441000"/>
            <a:ext cx="294948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F3880A-9AC4-462A-AD7C-9BE99FEB9DF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1166760" y="1243080"/>
            <a:ext cx="4471920" cy="335448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80760" y="4782960"/>
            <a:ext cx="5443560" cy="39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スライド番号プレースホルダー 3"/>
          <p:cNvSpPr/>
          <p:nvPr/>
        </p:nvSpPr>
        <p:spPr>
          <a:xfrm>
            <a:off x="3854520" y="9441000"/>
            <a:ext cx="2949480" cy="49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6CDEB6-92E7-4D30-BBD3-23A77AFFE30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22CEE-2B9A-4953-B182-CA982DEE4D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9916D-2E99-4881-8762-7295438581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E2EFE-2F58-48DE-BA1D-54F2709BEF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F2644-75CD-4A6D-BF8D-5D3AB767C7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76AD0-F267-417E-B94C-6748B245EE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D8A59-8717-4973-990D-534C520922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DCA7D-8122-4D09-835F-C0F2A38748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ED73B-EB00-44BA-B122-44F6EF2653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4ABED-A3AD-4511-B812-4D092595B2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B4837-8A19-4D36-A086-E575D42D1A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6C0FB-84AF-4EEF-B09E-916A2DD77A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6D0C4-E47E-4C51-8E66-B8E092CC1B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0D3322-DCA6-4F3C-A7FA-A5C3F995EF3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3" descr=""/>
          <p:cNvPicPr/>
          <p:nvPr/>
        </p:nvPicPr>
        <p:blipFill>
          <a:blip r:embed="rId1"/>
          <a:stretch/>
        </p:blipFill>
        <p:spPr>
          <a:xfrm>
            <a:off x="1477800" y="44280"/>
            <a:ext cx="6220080" cy="608040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4"/>
          <p:cNvSpPr/>
          <p:nvPr/>
        </p:nvSpPr>
        <p:spPr>
          <a:xfrm>
            <a:off x="7597800" y="1844640"/>
            <a:ext cx="1535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I_r1.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Total: 59,308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5"/>
          <p:cNvSpPr/>
          <p:nvPr/>
        </p:nvSpPr>
        <p:spPr>
          <a:xfrm>
            <a:off x="6485040" y="5332320"/>
            <a:ext cx="1535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NI_r1.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Total: 72,34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6"/>
          <p:cNvSpPr/>
          <p:nvPr/>
        </p:nvSpPr>
        <p:spPr>
          <a:xfrm>
            <a:off x="979560" y="5373720"/>
            <a:ext cx="1535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NU_r1.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Total: 70,203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7"/>
          <p:cNvSpPr/>
          <p:nvPr/>
        </p:nvSpPr>
        <p:spPr>
          <a:xfrm>
            <a:off x="476280" y="836640"/>
            <a:ext cx="1535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F. vesca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1.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Total: 34,809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8"/>
          <p:cNvSpPr/>
          <p:nvPr/>
        </p:nvSpPr>
        <p:spPr>
          <a:xfrm>
            <a:off x="5894280" y="117360"/>
            <a:ext cx="1651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AN_r1.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Total: 173,43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9"/>
          <p:cNvSpPr/>
          <p:nvPr/>
        </p:nvSpPr>
        <p:spPr>
          <a:xfrm>
            <a:off x="3570120" y="2762280"/>
            <a:ext cx="20354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6,18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FAN:83,743,FII:31,535, FNI:41,548, FNU:43,265, vesca:21,954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11"/>
          <p:cNvSpPr/>
          <p:nvPr/>
        </p:nvSpPr>
        <p:spPr>
          <a:xfrm>
            <a:off x="4141800" y="312840"/>
            <a:ext cx="1181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4,27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FAN:24,596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2"/>
          <p:cNvSpPr/>
          <p:nvPr/>
        </p:nvSpPr>
        <p:spPr>
          <a:xfrm>
            <a:off x="6661080" y="2401920"/>
            <a:ext cx="1181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,86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FII:3,989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13"/>
          <p:cNvSpPr/>
          <p:nvPr/>
        </p:nvSpPr>
        <p:spPr>
          <a:xfrm>
            <a:off x="6157800" y="326556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1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14"/>
          <p:cNvSpPr/>
          <p:nvPr/>
        </p:nvSpPr>
        <p:spPr>
          <a:xfrm>
            <a:off x="5869080" y="386064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3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15"/>
          <p:cNvSpPr/>
          <p:nvPr/>
        </p:nvSpPr>
        <p:spPr>
          <a:xfrm>
            <a:off x="5869080" y="420228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87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16"/>
          <p:cNvSpPr/>
          <p:nvPr/>
        </p:nvSpPr>
        <p:spPr>
          <a:xfrm>
            <a:off x="5029200" y="4363920"/>
            <a:ext cx="66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49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17"/>
          <p:cNvSpPr/>
          <p:nvPr/>
        </p:nvSpPr>
        <p:spPr>
          <a:xfrm>
            <a:off x="5726160" y="276084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52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18"/>
          <p:cNvSpPr/>
          <p:nvPr/>
        </p:nvSpPr>
        <p:spPr>
          <a:xfrm>
            <a:off x="5437080" y="3716280"/>
            <a:ext cx="5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83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19"/>
          <p:cNvSpPr/>
          <p:nvPr/>
        </p:nvSpPr>
        <p:spPr>
          <a:xfrm>
            <a:off x="5797440" y="1897200"/>
            <a:ext cx="6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,58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20"/>
          <p:cNvSpPr/>
          <p:nvPr/>
        </p:nvSpPr>
        <p:spPr>
          <a:xfrm>
            <a:off x="5294160" y="218448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97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21"/>
          <p:cNvSpPr/>
          <p:nvPr/>
        </p:nvSpPr>
        <p:spPr>
          <a:xfrm>
            <a:off x="3637080" y="1897200"/>
            <a:ext cx="64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80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22"/>
          <p:cNvSpPr/>
          <p:nvPr/>
        </p:nvSpPr>
        <p:spPr>
          <a:xfrm>
            <a:off x="5005440" y="1320840"/>
            <a:ext cx="6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,84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23"/>
          <p:cNvSpPr/>
          <p:nvPr/>
        </p:nvSpPr>
        <p:spPr>
          <a:xfrm>
            <a:off x="4357800" y="1557360"/>
            <a:ext cx="6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01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24"/>
          <p:cNvSpPr/>
          <p:nvPr/>
        </p:nvSpPr>
        <p:spPr>
          <a:xfrm>
            <a:off x="2917800" y="328464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56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25"/>
          <p:cNvSpPr/>
          <p:nvPr/>
        </p:nvSpPr>
        <p:spPr>
          <a:xfrm>
            <a:off x="3925800" y="4417920"/>
            <a:ext cx="59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,02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26"/>
          <p:cNvSpPr/>
          <p:nvPr/>
        </p:nvSpPr>
        <p:spPr>
          <a:xfrm>
            <a:off x="4645080" y="4992840"/>
            <a:ext cx="64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,47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27"/>
          <p:cNvSpPr/>
          <p:nvPr/>
        </p:nvSpPr>
        <p:spPr>
          <a:xfrm>
            <a:off x="3276720" y="429264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9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テキスト ボックス 28"/>
          <p:cNvSpPr/>
          <p:nvPr/>
        </p:nvSpPr>
        <p:spPr>
          <a:xfrm>
            <a:off x="3565440" y="4971960"/>
            <a:ext cx="6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33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29"/>
          <p:cNvSpPr/>
          <p:nvPr/>
        </p:nvSpPr>
        <p:spPr>
          <a:xfrm>
            <a:off x="2917800" y="247320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5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テキスト ボックス 30"/>
          <p:cNvSpPr/>
          <p:nvPr/>
        </p:nvSpPr>
        <p:spPr>
          <a:xfrm>
            <a:off x="2773440" y="1825560"/>
            <a:ext cx="5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9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テキスト ボックス 31"/>
          <p:cNvSpPr/>
          <p:nvPr/>
        </p:nvSpPr>
        <p:spPr>
          <a:xfrm>
            <a:off x="2629080" y="41292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60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33"/>
          <p:cNvSpPr/>
          <p:nvPr/>
        </p:nvSpPr>
        <p:spPr>
          <a:xfrm>
            <a:off x="5149800" y="5425920"/>
            <a:ext cx="1181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5,49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FNI:6,35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34"/>
          <p:cNvSpPr/>
          <p:nvPr/>
        </p:nvSpPr>
        <p:spPr>
          <a:xfrm>
            <a:off x="1521000" y="1825560"/>
            <a:ext cx="1180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48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vesca:1,59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35"/>
          <p:cNvSpPr/>
          <p:nvPr/>
        </p:nvSpPr>
        <p:spPr>
          <a:xfrm>
            <a:off x="2268360" y="4869000"/>
            <a:ext cx="1181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,97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(FNU:3,399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37"/>
          <p:cNvSpPr/>
          <p:nvPr/>
        </p:nvSpPr>
        <p:spPr>
          <a:xfrm>
            <a:off x="3541680" y="1227240"/>
            <a:ext cx="6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32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テキスト ボックス 38"/>
          <p:cNvSpPr/>
          <p:nvPr/>
        </p:nvSpPr>
        <p:spPr>
          <a:xfrm>
            <a:off x="3470400" y="1473120"/>
            <a:ext cx="59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68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テキスト ボックス 39"/>
          <p:cNvSpPr/>
          <p:nvPr/>
        </p:nvSpPr>
        <p:spPr>
          <a:xfrm>
            <a:off x="2486160" y="3387600"/>
            <a:ext cx="59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8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テキスト ボックス 40"/>
          <p:cNvSpPr/>
          <p:nvPr/>
        </p:nvSpPr>
        <p:spPr>
          <a:xfrm>
            <a:off x="2341440" y="3152880"/>
            <a:ext cx="59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59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41"/>
          <p:cNvSpPr/>
          <p:nvPr/>
        </p:nvSpPr>
        <p:spPr>
          <a:xfrm>
            <a:off x="5365800" y="1784520"/>
            <a:ext cx="6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15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42"/>
          <p:cNvSpPr/>
          <p:nvPr/>
        </p:nvSpPr>
        <p:spPr>
          <a:xfrm>
            <a:off x="3997440" y="4879800"/>
            <a:ext cx="6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,74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正方形/長方形 2"/>
          <p:cNvSpPr/>
          <p:nvPr/>
        </p:nvSpPr>
        <p:spPr>
          <a:xfrm>
            <a:off x="-50760" y="6216480"/>
            <a:ext cx="9194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S7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Venn diagram showing unique and shared intrinsic genes predicted i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. × ananass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. vesc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, and the Illumina-assembled genome sequences of the diploi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ragari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genomes. The gene sequences from the Illumina-assembled genomes used in this analysis were those labeled ‘intrinsic gene’ and ‘intrinsic gene/partial’, and are listed in Supplemental Table S13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23T00:36:32Z</dcterms:created>
  <dc:creator>Hideki Hirakawa</dc:creator>
  <dc:description/>
  <dc:language>en-US</dc:language>
  <cp:lastModifiedBy>Sachiko Isobe</cp:lastModifiedBy>
  <cp:lastPrinted>2013-08-27T03:00:12Z</cp:lastPrinted>
  <dcterms:modified xsi:type="dcterms:W3CDTF">2013-09-05T07:53:47Z</dcterms:modified>
  <cp:revision>25</cp:revision>
  <dc:subject/>
  <dc:title>PowerPoint プレゼンテーション</dc:title>
</cp:coreProperties>
</file>